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728"/>
    <p:restoredTop sz="94679"/>
  </p:normalViewPr>
  <p:slideViewPr>
    <p:cSldViewPr snapToGrid="0" snapToObjects="1" showGuides="1">
      <p:cViewPr>
        <p:scale>
          <a:sx n="96" d="100"/>
          <a:sy n="96" d="100"/>
        </p:scale>
        <p:origin x="720" y="-200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AE7F5FD-9F50-4443-8C66-4DC262ADA8E9}" type="datetimeFigureOut">
              <a:rPr lang="en-US" smtClean="0"/>
              <a:t>1/16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43F94B5-6E24-3B4B-937D-6D66F9A116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34779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43F94B5-6E24-3B4B-937D-6D66F9A1162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05387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6679D-2426-1C4D-A5C3-31B25BC8988D}" type="datetimeFigureOut">
              <a:rPr lang="en-US" smtClean="0"/>
              <a:t>1/1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E1943-6A73-374F-8C56-9358031502F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6679D-2426-1C4D-A5C3-31B25BC8988D}" type="datetimeFigureOut">
              <a:rPr lang="en-US" smtClean="0"/>
              <a:t>1/1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E1943-6A73-374F-8C56-9358031502F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6679D-2426-1C4D-A5C3-31B25BC8988D}" type="datetimeFigureOut">
              <a:rPr lang="en-US" smtClean="0"/>
              <a:t>1/1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E1943-6A73-374F-8C56-9358031502F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6679D-2426-1C4D-A5C3-31B25BC8988D}" type="datetimeFigureOut">
              <a:rPr lang="en-US" smtClean="0"/>
              <a:t>1/1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E1943-6A73-374F-8C56-9358031502F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6679D-2426-1C4D-A5C3-31B25BC8988D}" type="datetimeFigureOut">
              <a:rPr lang="en-US" smtClean="0"/>
              <a:t>1/1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E1943-6A73-374F-8C56-9358031502F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6679D-2426-1C4D-A5C3-31B25BC8988D}" type="datetimeFigureOut">
              <a:rPr lang="en-US" smtClean="0"/>
              <a:t>1/1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E1943-6A73-374F-8C56-9358031502F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6679D-2426-1C4D-A5C3-31B25BC8988D}" type="datetimeFigureOut">
              <a:rPr lang="en-US" smtClean="0"/>
              <a:t>1/16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E1943-6A73-374F-8C56-9358031502F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6679D-2426-1C4D-A5C3-31B25BC8988D}" type="datetimeFigureOut">
              <a:rPr lang="en-US" smtClean="0"/>
              <a:t>1/16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E1943-6A73-374F-8C56-9358031502F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6679D-2426-1C4D-A5C3-31B25BC8988D}" type="datetimeFigureOut">
              <a:rPr lang="en-US" smtClean="0"/>
              <a:t>1/16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E1943-6A73-374F-8C56-9358031502F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6679D-2426-1C4D-A5C3-31B25BC8988D}" type="datetimeFigureOut">
              <a:rPr lang="en-US" smtClean="0"/>
              <a:t>1/1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E1943-6A73-374F-8C56-9358031502F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6679D-2426-1C4D-A5C3-31B25BC8988D}" type="datetimeFigureOut">
              <a:rPr lang="en-US" smtClean="0"/>
              <a:t>1/1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E1943-6A73-374F-8C56-9358031502F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16679D-2426-1C4D-A5C3-31B25BC8988D}" type="datetimeFigureOut">
              <a:rPr lang="en-US" smtClean="0"/>
              <a:t>1/1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0E1943-6A73-374F-8C56-9358031502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51414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478045" y="9052529"/>
            <a:ext cx="608274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smtClean="0"/>
              <a:t>Variant Position Table </a:t>
            </a:r>
            <a:r>
              <a:rPr lang="en-US" sz="1200" dirty="0" smtClean="0"/>
              <a:t>detailing variants at all positions </a:t>
            </a:r>
            <a:r>
              <a:rPr lang="en-US" sz="1200" dirty="0"/>
              <a:t>with at least one non-synonymous variant</a:t>
            </a:r>
            <a:r>
              <a:rPr lang="en-US" sz="1200" dirty="0" smtClean="0"/>
              <a:t> found to be significantly associated with a phenotype in any of the variant-based analyses.</a:t>
            </a:r>
            <a:endParaRPr lang="en-US" sz="1200" dirty="0"/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99752961"/>
              </p:ext>
            </p:extLst>
          </p:nvPr>
        </p:nvGraphicFramePr>
        <p:xfrm>
          <a:off x="492264" y="386074"/>
          <a:ext cx="6054310" cy="8552010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626076"/>
                <a:gridCol w="405660"/>
                <a:gridCol w="715617"/>
                <a:gridCol w="728870"/>
                <a:gridCol w="3578087"/>
              </a:tblGrid>
              <a:tr h="11466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Position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Type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Reference</a:t>
                      </a:r>
                      <a:endParaRPr lang="en-US" sz="11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Alternative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Variant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</a:tr>
              <a:tr h="121693">
                <a:tc>
                  <a:txBody>
                    <a:bodyPr/>
                    <a:lstStyle/>
                    <a:p>
                      <a:pPr algn="l" fontAlgn="b"/>
                      <a:r>
                        <a:rPr lang="is-IS" sz="1100" u="none" strike="noStrike">
                          <a:effectLst/>
                          <a:latin typeface="+mn-lt"/>
                        </a:rPr>
                        <a:t>6620</a:t>
                      </a:r>
                      <a:endParaRPr lang="is-I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SN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_tradnl" sz="1100" u="none" strike="noStrike">
                          <a:effectLst/>
                          <a:latin typeface="+mn-lt"/>
                        </a:rPr>
                        <a:t>C,A</a:t>
                      </a:r>
                      <a:endParaRPr lang="es-ES_tradnl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mr-IN" sz="1100" u="none" strike="noStrike" dirty="0">
                          <a:effectLst/>
                          <a:latin typeface="+mn-lt"/>
                        </a:rPr>
                        <a:t>461D&gt;</a:t>
                      </a:r>
                      <a:r>
                        <a:rPr lang="mr-IN" sz="1100" u="none" strike="noStrike" dirty="0" err="1">
                          <a:effectLst/>
                          <a:latin typeface="+mn-lt"/>
                        </a:rPr>
                        <a:t>H</a:t>
                      </a:r>
                      <a:r>
                        <a:rPr lang="mr-IN" sz="1100" u="none" strike="noStrike" dirty="0">
                          <a:effectLst/>
                          <a:latin typeface="+mn-lt"/>
                        </a:rPr>
                        <a:t>, 461D&gt;</a:t>
                      </a:r>
                      <a:r>
                        <a:rPr lang="mr-IN" sz="1100" u="none" strike="noStrike" dirty="0" err="1">
                          <a:effectLst/>
                          <a:latin typeface="+mn-lt"/>
                        </a:rPr>
                        <a:t>N</a:t>
                      </a:r>
                      <a:endParaRPr lang="mr-IN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</a:tr>
              <a:tr h="121693">
                <a:tc>
                  <a:txBody>
                    <a:bodyPr/>
                    <a:lstStyle/>
                    <a:p>
                      <a:pPr algn="l" fontAlgn="b"/>
                      <a:r>
                        <a:rPr lang="ru-RU" sz="1100" u="none" strike="noStrike">
                          <a:effectLst/>
                          <a:latin typeface="+mn-lt"/>
                        </a:rPr>
                        <a:t>7570</a:t>
                      </a:r>
                      <a:endParaRPr lang="ru-RU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SN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C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_tradnl" sz="1100" u="none" strike="noStrike">
                          <a:effectLst/>
                          <a:latin typeface="+mn-lt"/>
                        </a:rPr>
                        <a:t>G,T</a:t>
                      </a:r>
                      <a:endParaRPr lang="es-ES_tradnl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mr-IN" sz="1100" u="none" strike="noStrike" dirty="0">
                          <a:effectLst/>
                          <a:latin typeface="+mn-lt"/>
                        </a:rPr>
                        <a:t>90A&gt;</a:t>
                      </a:r>
                      <a:r>
                        <a:rPr lang="mr-IN" sz="1100" u="none" strike="noStrike" dirty="0" err="1">
                          <a:effectLst/>
                          <a:latin typeface="+mn-lt"/>
                        </a:rPr>
                        <a:t>G</a:t>
                      </a:r>
                      <a:r>
                        <a:rPr lang="mr-IN" sz="1100" u="none" strike="noStrike" dirty="0">
                          <a:effectLst/>
                          <a:latin typeface="+mn-lt"/>
                        </a:rPr>
                        <a:t>, 90A&gt;V</a:t>
                      </a:r>
                      <a:endParaRPr lang="mr-IN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</a:tr>
              <a:tr h="121693">
                <a:tc>
                  <a:txBody>
                    <a:bodyPr/>
                    <a:lstStyle/>
                    <a:p>
                      <a:pPr algn="l" fontAlgn="b"/>
                      <a:r>
                        <a:rPr lang="is-IS" sz="1100" u="none" strike="noStrike">
                          <a:effectLst/>
                          <a:latin typeface="+mn-lt"/>
                        </a:rPr>
                        <a:t>7572</a:t>
                      </a:r>
                      <a:endParaRPr lang="is-I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SN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C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mr-IN" sz="1100" u="none" strike="noStrike">
                          <a:effectLst/>
                          <a:latin typeface="+mn-lt"/>
                        </a:rPr>
                        <a:t>91S&gt;P</a:t>
                      </a:r>
                      <a:endParaRPr lang="mr-IN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</a:tr>
              <a:tr h="121693">
                <a:tc>
                  <a:txBody>
                    <a:bodyPr/>
                    <a:lstStyle/>
                    <a:p>
                      <a:pPr algn="l" fontAlgn="b"/>
                      <a:r>
                        <a:rPr lang="ru-RU" sz="1100" u="none" strike="noStrike">
                          <a:effectLst/>
                          <a:latin typeface="+mn-lt"/>
                        </a:rPr>
                        <a:t>7581</a:t>
                      </a:r>
                      <a:endParaRPr lang="ru-RU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SN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_tradnl" sz="1100" u="none" strike="noStrike">
                          <a:effectLst/>
                          <a:latin typeface="+mn-lt"/>
                        </a:rPr>
                        <a:t>C,A,T</a:t>
                      </a:r>
                      <a:endParaRPr lang="es-ES_tradnl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mr-IN" sz="1100" u="none" strike="noStrike">
                          <a:effectLst/>
                          <a:latin typeface="+mn-lt"/>
                        </a:rPr>
                        <a:t>94D&gt;P, 94D&gt;F, 94D&gt;S</a:t>
                      </a:r>
                      <a:endParaRPr lang="mr-IN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</a:tr>
              <a:tr h="121693">
                <a:tc>
                  <a:txBody>
                    <a:bodyPr/>
                    <a:lstStyle/>
                    <a:p>
                      <a:pPr algn="l" fontAlgn="b"/>
                      <a:r>
                        <a:rPr lang="is-IS" sz="1100" u="none" strike="noStrike">
                          <a:effectLst/>
                          <a:latin typeface="+mn-lt"/>
                        </a:rPr>
                        <a:t>7572</a:t>
                      </a:r>
                      <a:endParaRPr lang="is-I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SN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C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mr-IN" sz="1100" u="none" strike="noStrike">
                          <a:effectLst/>
                          <a:latin typeface="+mn-lt"/>
                        </a:rPr>
                        <a:t>91S&gt;P</a:t>
                      </a:r>
                      <a:endParaRPr lang="mr-IN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</a:tr>
              <a:tr h="121693">
                <a:tc>
                  <a:txBody>
                    <a:bodyPr/>
                    <a:lstStyle/>
                    <a:p>
                      <a:pPr algn="l" fontAlgn="b"/>
                      <a:r>
                        <a:rPr lang="is-IS" sz="1100" u="none" strike="noStrike">
                          <a:effectLst/>
                          <a:latin typeface="+mn-lt"/>
                        </a:rPr>
                        <a:t>232574</a:t>
                      </a:r>
                      <a:endParaRPr lang="is-I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SN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mr-IN" sz="1100" u="none" strike="noStrike">
                          <a:effectLst/>
                          <a:latin typeface="+mn-lt"/>
                        </a:rPr>
                        <a:t>115G&gt;V</a:t>
                      </a:r>
                      <a:endParaRPr lang="mr-IN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</a:tr>
              <a:tr h="121693">
                <a:tc>
                  <a:txBody>
                    <a:bodyPr/>
                    <a:lstStyle/>
                    <a:p>
                      <a:pPr algn="l" fontAlgn="b"/>
                      <a:r>
                        <a:rPr lang="is-IS" sz="1100" u="none" strike="noStrike">
                          <a:effectLst/>
                          <a:latin typeface="+mn-lt"/>
                        </a:rPr>
                        <a:t>732110</a:t>
                      </a:r>
                      <a:endParaRPr lang="is-I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SN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_tradnl" sz="1100" u="none" strike="noStrike">
                          <a:effectLst/>
                          <a:latin typeface="+mn-lt"/>
                        </a:rPr>
                        <a:t>A,G</a:t>
                      </a:r>
                      <a:endParaRPr lang="es-ES_tradnl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mr-IN" sz="1100" u="none" strike="noStrike">
                          <a:effectLst/>
                          <a:latin typeface="+mn-lt"/>
                        </a:rPr>
                        <a:t>61C&gt;S, 61C&gt;G</a:t>
                      </a:r>
                      <a:endParaRPr lang="mr-IN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</a:tr>
              <a:tr h="121693">
                <a:tc>
                  <a:txBody>
                    <a:bodyPr/>
                    <a:lstStyle/>
                    <a:p>
                      <a:pPr algn="l" fontAlgn="b"/>
                      <a:r>
                        <a:rPr lang="uk-UA" sz="1100" u="none" strike="noStrike">
                          <a:effectLst/>
                          <a:latin typeface="+mn-lt"/>
                        </a:rPr>
                        <a:t>759939</a:t>
                      </a:r>
                      <a:endParaRPr lang="uk-UA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SN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C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_tradnl" sz="1100" u="none" strike="noStrike">
                          <a:effectLst/>
                          <a:latin typeface="+mn-lt"/>
                        </a:rPr>
                        <a:t>G,T</a:t>
                      </a:r>
                      <a:endParaRPr lang="es-ES_tradnl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mr-IN" sz="1100" u="none" strike="noStrike">
                          <a:effectLst/>
                          <a:latin typeface="+mn-lt"/>
                        </a:rPr>
                        <a:t>45P&gt;A, 45P&gt;S</a:t>
                      </a:r>
                      <a:endParaRPr lang="mr-IN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</a:tr>
              <a:tr h="121693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76031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SN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_tradnl" sz="1100" u="none" strike="noStrike">
                          <a:effectLst/>
                          <a:latin typeface="+mn-lt"/>
                        </a:rPr>
                        <a:t>C,T</a:t>
                      </a:r>
                      <a:endParaRPr lang="es-ES_tradnl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mr-IN" sz="1100" u="none" strike="noStrike">
                          <a:effectLst/>
                          <a:latin typeface="+mn-lt"/>
                        </a:rPr>
                        <a:t>170V&gt;L, 170V&gt;F</a:t>
                      </a:r>
                      <a:endParaRPr lang="mr-IN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</a:tr>
              <a:tr h="121693">
                <a:tc>
                  <a:txBody>
                    <a:bodyPr/>
                    <a:lstStyle/>
                    <a:p>
                      <a:pPr algn="l" fontAlgn="b"/>
                      <a:r>
                        <a:rPr lang="is-IS" sz="1100" u="none" strike="noStrike">
                          <a:effectLst/>
                          <a:latin typeface="+mn-lt"/>
                        </a:rPr>
                        <a:t>761095</a:t>
                      </a:r>
                      <a:endParaRPr lang="is-I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SN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_tradnl" sz="1100" u="none" strike="noStrike">
                          <a:effectLst/>
                          <a:latin typeface="+mn-lt"/>
                        </a:rPr>
                        <a:t>C,G</a:t>
                      </a:r>
                      <a:endParaRPr lang="es-ES_tradnl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mr-IN" sz="1100" u="none" strike="noStrike">
                          <a:effectLst/>
                          <a:latin typeface="+mn-lt"/>
                        </a:rPr>
                        <a:t>430L&gt;P, 430L&gt;R</a:t>
                      </a:r>
                      <a:endParaRPr lang="mr-IN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</a:tr>
              <a:tr h="121693">
                <a:tc>
                  <a:txBody>
                    <a:bodyPr/>
                    <a:lstStyle/>
                    <a:p>
                      <a:pPr algn="l" fontAlgn="b"/>
                      <a:r>
                        <a:rPr lang="is-IS" sz="1100" u="none" strike="noStrike">
                          <a:effectLst/>
                          <a:latin typeface="+mn-lt"/>
                        </a:rPr>
                        <a:t>761109</a:t>
                      </a:r>
                      <a:endParaRPr lang="is-I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SN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mr-IN" sz="1100" u="none" strike="noStrike">
                          <a:effectLst/>
                          <a:latin typeface="+mn-lt"/>
                        </a:rPr>
                        <a:t>435D&gt;Y</a:t>
                      </a:r>
                      <a:endParaRPr lang="mr-IN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</a:tr>
              <a:tr h="114669">
                <a:tc>
                  <a:txBody>
                    <a:bodyPr/>
                    <a:lstStyle/>
                    <a:p>
                      <a:pPr algn="l" fontAlgn="b"/>
                      <a:r>
                        <a:rPr lang="cs-CZ" sz="1100" u="none" strike="noStrike">
                          <a:effectLst/>
                          <a:latin typeface="+mn-lt"/>
                        </a:rPr>
                        <a:t>761110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SN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_tradnl" sz="1100" u="none" strike="noStrike">
                          <a:effectLst/>
                          <a:latin typeface="+mn-lt"/>
                        </a:rPr>
                        <a:t>C,G,T</a:t>
                      </a:r>
                      <a:endParaRPr lang="es-ES_tradnl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mr-IN" sz="1100" u="none" strike="noStrike">
                          <a:effectLst/>
                          <a:latin typeface="+mn-lt"/>
                        </a:rPr>
                        <a:t>435D&gt;A, 435D&gt;G, 435D&gt;V</a:t>
                      </a:r>
                      <a:endParaRPr lang="mr-IN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</a:tr>
              <a:tr h="127489">
                <a:tc>
                  <a:txBody>
                    <a:bodyPr/>
                    <a:lstStyle/>
                    <a:p>
                      <a:pPr algn="l" fontAlgn="b"/>
                      <a:r>
                        <a:rPr lang="is-IS" sz="1100" u="none" strike="noStrike">
                          <a:effectLst/>
                          <a:latin typeface="+mn-lt"/>
                        </a:rPr>
                        <a:t>761139</a:t>
                      </a:r>
                      <a:endParaRPr lang="is-I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SN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C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_tradnl" sz="1100" u="none" strike="noStrike">
                          <a:effectLst/>
                          <a:latin typeface="+mn-lt"/>
                        </a:rPr>
                        <a:t>A,G,T</a:t>
                      </a:r>
                      <a:endParaRPr lang="es-ES_tradnl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mr-IN" sz="1100" u="none" strike="noStrike">
                          <a:effectLst/>
                          <a:latin typeface="+mn-lt"/>
                        </a:rPr>
                        <a:t>445H&gt;N,  445H&gt;D, 445H&gt;Y</a:t>
                      </a:r>
                      <a:endParaRPr lang="mr-IN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</a:tr>
              <a:tr h="121693">
                <a:tc>
                  <a:txBody>
                    <a:bodyPr/>
                    <a:lstStyle/>
                    <a:p>
                      <a:pPr algn="l" fontAlgn="b"/>
                      <a:r>
                        <a:rPr lang="cs-CZ" sz="1100" u="none" strike="noStrike">
                          <a:effectLst/>
                          <a:latin typeface="+mn-lt"/>
                        </a:rPr>
                        <a:t>761140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SN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_tradnl" sz="1100" u="none" strike="noStrike">
                          <a:effectLst/>
                          <a:latin typeface="+mn-lt"/>
                        </a:rPr>
                        <a:t>C,G,T</a:t>
                      </a:r>
                      <a:endParaRPr lang="es-ES_tradnl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mr-IN" sz="1100" u="none" strike="noStrike">
                          <a:effectLst/>
                          <a:latin typeface="+mn-lt"/>
                        </a:rPr>
                        <a:t>445H&gt;P, 445H&gt;R, 445H&gt;L</a:t>
                      </a:r>
                      <a:endParaRPr lang="mr-IN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</a:tr>
              <a:tr h="121693">
                <a:tc>
                  <a:txBody>
                    <a:bodyPr/>
                    <a:lstStyle/>
                    <a:p>
                      <a:pPr algn="l" fontAlgn="b"/>
                      <a:r>
                        <a:rPr lang="cs-CZ" sz="1100" u="none" strike="noStrike">
                          <a:effectLst/>
                          <a:latin typeface="+mn-lt"/>
                        </a:rPr>
                        <a:t>761155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SN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C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_tradnl" sz="1100" u="none" strike="noStrike">
                          <a:effectLst/>
                          <a:latin typeface="+mn-lt"/>
                        </a:rPr>
                        <a:t>G,T</a:t>
                      </a:r>
                      <a:endParaRPr lang="es-ES_tradnl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mr-IN" sz="1100" u="none" strike="noStrike">
                          <a:effectLst/>
                          <a:latin typeface="+mn-lt"/>
                        </a:rPr>
                        <a:t>450S&gt;W, 450S&gt;L</a:t>
                      </a:r>
                      <a:endParaRPr lang="mr-IN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</a:tr>
              <a:tr h="121693">
                <a:tc>
                  <a:txBody>
                    <a:bodyPr/>
                    <a:lstStyle/>
                    <a:p>
                      <a:pPr algn="l" fontAlgn="b"/>
                      <a:r>
                        <a:rPr lang="cs-CZ" sz="1100" u="none" strike="noStrike">
                          <a:effectLst/>
                          <a:latin typeface="+mn-lt"/>
                        </a:rPr>
                        <a:t>761161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SN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C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mr-IN" sz="1100" u="none" strike="noStrike">
                          <a:effectLst/>
                          <a:latin typeface="+mn-lt"/>
                        </a:rPr>
                        <a:t>452L&gt;P</a:t>
                      </a:r>
                      <a:endParaRPr lang="mr-IN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</a:tr>
              <a:tr h="121693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76199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SN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C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mr-IN" sz="1100" u="none" strike="noStrike">
                          <a:effectLst/>
                          <a:latin typeface="+mn-lt"/>
                        </a:rPr>
                        <a:t>731L&gt;P</a:t>
                      </a:r>
                      <a:endParaRPr lang="mr-IN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</a:tr>
              <a:tr h="123532">
                <a:tc>
                  <a:txBody>
                    <a:bodyPr/>
                    <a:lstStyle/>
                    <a:p>
                      <a:pPr algn="l" fontAlgn="b"/>
                      <a:r>
                        <a:rPr lang="is-IS" sz="1100" u="none" strike="noStrike">
                          <a:effectLst/>
                          <a:latin typeface="+mn-lt"/>
                        </a:rPr>
                        <a:t>764363</a:t>
                      </a:r>
                      <a:endParaRPr lang="is-I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SN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_tradnl" sz="1100" u="none" strike="noStrike">
                          <a:effectLst/>
                          <a:latin typeface="+mn-lt"/>
                        </a:rPr>
                        <a:t>C,A,T</a:t>
                      </a:r>
                      <a:endParaRPr lang="es-ES_tradnl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mr-IN" sz="1100" u="none" strike="noStrike">
                          <a:effectLst/>
                          <a:latin typeface="+mn-lt"/>
                        </a:rPr>
                        <a:t>332G&gt;R, 332G&gt;S, 332G&gt;C</a:t>
                      </a:r>
                      <a:endParaRPr lang="mr-IN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</a:tr>
              <a:tr h="121693">
                <a:tc>
                  <a:txBody>
                    <a:bodyPr/>
                    <a:lstStyle/>
                    <a:p>
                      <a:pPr algn="l" fontAlgn="b"/>
                      <a:r>
                        <a:rPr lang="is-IS" sz="1100" u="none" strike="noStrike">
                          <a:effectLst/>
                          <a:latin typeface="+mn-lt"/>
                        </a:rPr>
                        <a:t>764817</a:t>
                      </a:r>
                      <a:endParaRPr lang="is-I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SN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_tradnl" sz="1100" u="none" strike="noStrike">
                          <a:effectLst/>
                          <a:latin typeface="+mn-lt"/>
                        </a:rPr>
                        <a:t>C,G</a:t>
                      </a:r>
                      <a:endParaRPr lang="es-ES_tradnl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mr-IN" sz="1100" u="none" strike="noStrike">
                          <a:effectLst/>
                          <a:latin typeface="+mn-lt"/>
                        </a:rPr>
                        <a:t>483V&gt;A, 483V&gt;G</a:t>
                      </a:r>
                      <a:endParaRPr lang="mr-IN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</a:tr>
              <a:tr h="121693">
                <a:tc>
                  <a:txBody>
                    <a:bodyPr/>
                    <a:lstStyle/>
                    <a:p>
                      <a:pPr algn="l" fontAlgn="b"/>
                      <a:r>
                        <a:rPr lang="is-IS" sz="1100" u="none" strike="noStrike">
                          <a:effectLst/>
                          <a:latin typeface="+mn-lt"/>
                        </a:rPr>
                        <a:t>764840</a:t>
                      </a:r>
                      <a:endParaRPr lang="is-I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SN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mr-IN" sz="1100" u="none" strike="noStrike">
                          <a:effectLst/>
                          <a:latin typeface="+mn-lt"/>
                        </a:rPr>
                        <a:t>491I&gt;V</a:t>
                      </a:r>
                      <a:endParaRPr lang="mr-IN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</a:tr>
              <a:tr h="121693">
                <a:tc>
                  <a:txBody>
                    <a:bodyPr/>
                    <a:lstStyle/>
                    <a:p>
                      <a:pPr algn="l" fontAlgn="b"/>
                      <a:r>
                        <a:rPr lang="is-IS" sz="1100" u="none" strike="noStrike">
                          <a:effectLst/>
                          <a:latin typeface="+mn-lt"/>
                        </a:rPr>
                        <a:t>767123</a:t>
                      </a:r>
                      <a:endParaRPr lang="is-I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SN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_tradnl" sz="1100" u="none" strike="noStrike">
                          <a:effectLst/>
                          <a:latin typeface="+mn-lt"/>
                        </a:rPr>
                        <a:t>A,T</a:t>
                      </a:r>
                      <a:endParaRPr lang="es-ES_tradnl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mr-IN" sz="1100" u="none" strike="noStrike">
                          <a:effectLst/>
                          <a:latin typeface="+mn-lt"/>
                        </a:rPr>
                        <a:t>1252V&gt;M, 1252V&gt;L</a:t>
                      </a:r>
                      <a:endParaRPr lang="mr-IN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</a:tr>
              <a:tr h="121693">
                <a:tc>
                  <a:txBody>
                    <a:bodyPr/>
                    <a:lstStyle/>
                    <a:p>
                      <a:pPr algn="l" fontAlgn="b"/>
                      <a:r>
                        <a:rPr lang="is-IS" sz="1100" u="none" strike="noStrike">
                          <a:effectLst/>
                          <a:latin typeface="+mn-lt"/>
                        </a:rPr>
                        <a:t>781687</a:t>
                      </a:r>
                      <a:endParaRPr lang="is-I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SNP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mr-IN" sz="1100" u="none" strike="noStrike">
                          <a:effectLst/>
                          <a:latin typeface="+mn-lt"/>
                        </a:rPr>
                        <a:t>43K&gt;R</a:t>
                      </a:r>
                      <a:endParaRPr lang="mr-IN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</a:tr>
              <a:tr h="121693">
                <a:tc>
                  <a:txBody>
                    <a:bodyPr/>
                    <a:lstStyle/>
                    <a:p>
                      <a:pPr algn="l" fontAlgn="b"/>
                      <a:r>
                        <a:rPr lang="is-IS" sz="1100" u="none" strike="noStrike">
                          <a:effectLst/>
                          <a:latin typeface="+mn-lt"/>
                        </a:rPr>
                        <a:t>781822</a:t>
                      </a:r>
                      <a:endParaRPr lang="is-I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SN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_tradnl" sz="1100" u="none" strike="noStrike">
                          <a:effectLst/>
                          <a:latin typeface="+mn-lt"/>
                        </a:rPr>
                        <a:t>C,G,T</a:t>
                      </a:r>
                      <a:endParaRPr lang="es-ES_tradnl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mr-IN" sz="1100" u="none" strike="noStrike" dirty="0">
                          <a:effectLst/>
                          <a:latin typeface="+mn-lt"/>
                        </a:rPr>
                        <a:t>88K&gt;</a:t>
                      </a:r>
                      <a:r>
                        <a:rPr lang="mr-IN" sz="1100" u="none" strike="noStrike" dirty="0" err="1">
                          <a:effectLst/>
                          <a:latin typeface="+mn-lt"/>
                        </a:rPr>
                        <a:t>T</a:t>
                      </a:r>
                      <a:r>
                        <a:rPr lang="mr-IN" sz="1100" u="none" strike="noStrike" dirty="0">
                          <a:effectLst/>
                          <a:latin typeface="+mn-lt"/>
                        </a:rPr>
                        <a:t>, 88K&gt;</a:t>
                      </a:r>
                      <a:r>
                        <a:rPr lang="mr-IN" sz="1100" u="none" strike="noStrike" dirty="0" err="1">
                          <a:effectLst/>
                          <a:latin typeface="+mn-lt"/>
                        </a:rPr>
                        <a:t>R</a:t>
                      </a:r>
                      <a:r>
                        <a:rPr lang="mr-IN" sz="1100" u="none" strike="noStrike" dirty="0">
                          <a:effectLst/>
                          <a:latin typeface="+mn-lt"/>
                        </a:rPr>
                        <a:t>, 88K&gt;M</a:t>
                      </a:r>
                      <a:endParaRPr lang="mr-IN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</a:tr>
              <a:tr h="137451">
                <a:tc>
                  <a:txBody>
                    <a:bodyPr/>
                    <a:lstStyle/>
                    <a:p>
                      <a:pPr algn="l" fontAlgn="b"/>
                      <a:r>
                        <a:rPr lang="is-IS" sz="1100" u="none" strike="noStrike">
                          <a:effectLst/>
                          <a:latin typeface="+mn-lt"/>
                        </a:rPr>
                        <a:t>2155167</a:t>
                      </a:r>
                      <a:endParaRPr lang="is-I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SN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tr-TR" sz="1100" u="none" strike="noStrike">
                          <a:effectLst/>
                          <a:latin typeface="+mn-lt"/>
                        </a:rPr>
                        <a:t>T,A</a:t>
                      </a:r>
                      <a:endParaRPr lang="tr-TR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1100" u="none" strike="noStrike" dirty="0">
                          <a:effectLst/>
                          <a:latin typeface="+mn-lt"/>
                        </a:rPr>
                        <a:t>315S&gt;</a:t>
                      </a:r>
                      <a:r>
                        <a:rPr lang="it-IT" sz="1100" u="none" strike="noStrike" dirty="0" err="1">
                          <a:effectLst/>
                          <a:latin typeface="+mn-lt"/>
                        </a:rPr>
                        <a:t>R</a:t>
                      </a:r>
                      <a:r>
                        <a:rPr lang="it-IT" sz="1100" u="none" strike="noStrike" dirty="0">
                          <a:effectLst/>
                          <a:latin typeface="+mn-lt"/>
                        </a:rPr>
                        <a:t>, 315S</a:t>
                      </a:r>
                      <a:endParaRPr lang="it-IT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</a:tr>
              <a:tr h="127239">
                <a:tc>
                  <a:txBody>
                    <a:bodyPr/>
                    <a:lstStyle/>
                    <a:p>
                      <a:pPr algn="l" fontAlgn="b"/>
                      <a:r>
                        <a:rPr lang="is-IS" sz="1100" u="none" strike="noStrike">
                          <a:effectLst/>
                          <a:latin typeface="+mn-lt"/>
                        </a:rPr>
                        <a:t>2155168</a:t>
                      </a:r>
                      <a:endParaRPr lang="is-I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SN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C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_tradnl" sz="1100" u="none" strike="noStrike">
                          <a:effectLst/>
                          <a:latin typeface="+mn-lt"/>
                        </a:rPr>
                        <a:t>A,G,T</a:t>
                      </a:r>
                      <a:endParaRPr lang="es-ES_tradnl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mr-IN" sz="1100" u="none" strike="noStrike">
                          <a:effectLst/>
                          <a:latin typeface="+mn-lt"/>
                        </a:rPr>
                        <a:t>315S&gt;I, 315S&gt;K, 315S&gt;T, 315S&gt;I</a:t>
                      </a:r>
                      <a:endParaRPr lang="mr-IN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</a:tr>
              <a:tr h="114669">
                <a:tc>
                  <a:txBody>
                    <a:bodyPr/>
                    <a:lstStyle/>
                    <a:p>
                      <a:pPr algn="l" fontAlgn="b"/>
                      <a:r>
                        <a:rPr lang="is-IS" sz="1100" u="none" strike="noStrike">
                          <a:effectLst/>
                          <a:latin typeface="+mn-lt"/>
                        </a:rPr>
                        <a:t>2288764</a:t>
                      </a:r>
                      <a:endParaRPr lang="is-I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SN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_tradnl" sz="1100" u="none" strike="noStrike">
                          <a:effectLst/>
                          <a:latin typeface="+mn-lt"/>
                        </a:rPr>
                        <a:t>C,G</a:t>
                      </a:r>
                      <a:endParaRPr lang="es-ES_tradnl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mr-IN" sz="1100" u="none" strike="noStrike">
                          <a:effectLst/>
                          <a:latin typeface="+mn-lt"/>
                        </a:rPr>
                        <a:t>160T&gt;A, 160T&gt;P</a:t>
                      </a:r>
                      <a:endParaRPr lang="mr-IN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</a:tr>
              <a:tr h="114669">
                <a:tc>
                  <a:txBody>
                    <a:bodyPr/>
                    <a:lstStyle/>
                    <a:p>
                      <a:pPr algn="l" fontAlgn="b"/>
                      <a:r>
                        <a:rPr lang="is-IS" sz="1100" u="none" strike="noStrike">
                          <a:effectLst/>
                          <a:latin typeface="+mn-lt"/>
                        </a:rPr>
                        <a:t>2288778</a:t>
                      </a:r>
                      <a:endParaRPr lang="is-I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SN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_tradnl" sz="1100" u="none" strike="noStrike">
                          <a:effectLst/>
                          <a:latin typeface="+mn-lt"/>
                        </a:rPr>
                        <a:t>C,G</a:t>
                      </a:r>
                      <a:endParaRPr lang="es-ES_tradnl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mr-IN" sz="1100" u="none" strike="noStrike" dirty="0">
                          <a:effectLst/>
                          <a:latin typeface="+mn-lt"/>
                        </a:rPr>
                        <a:t>155V&gt;</a:t>
                      </a:r>
                      <a:r>
                        <a:rPr lang="mr-IN" sz="1100" u="none" strike="noStrike" dirty="0" err="1">
                          <a:effectLst/>
                          <a:latin typeface="+mn-lt"/>
                        </a:rPr>
                        <a:t>G</a:t>
                      </a:r>
                      <a:r>
                        <a:rPr lang="mr-IN" sz="1100" u="none" strike="noStrike" dirty="0">
                          <a:effectLst/>
                          <a:latin typeface="+mn-lt"/>
                        </a:rPr>
                        <a:t>, 155V&gt;</a:t>
                      </a:r>
                      <a:r>
                        <a:rPr lang="mr-IN" sz="1100" u="none" strike="noStrike" dirty="0" err="1">
                          <a:effectLst/>
                          <a:latin typeface="+mn-lt"/>
                        </a:rPr>
                        <a:t>A</a:t>
                      </a:r>
                      <a:endParaRPr lang="mr-IN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</a:tr>
              <a:tr h="114669">
                <a:tc>
                  <a:txBody>
                    <a:bodyPr/>
                    <a:lstStyle/>
                    <a:p>
                      <a:pPr algn="l" fontAlgn="b"/>
                      <a:r>
                        <a:rPr lang="is-IS" sz="1100" u="none" strike="noStrike">
                          <a:effectLst/>
                          <a:latin typeface="+mn-lt"/>
                        </a:rPr>
                        <a:t>2288820</a:t>
                      </a:r>
                      <a:endParaRPr lang="is-I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SN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mr-IN" sz="1100" u="none" strike="noStrike">
                          <a:effectLst/>
                          <a:latin typeface="+mn-lt"/>
                        </a:rPr>
                        <a:t>141Q&gt;P</a:t>
                      </a:r>
                      <a:endParaRPr lang="mr-IN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</a:tr>
              <a:tr h="152028">
                <a:tc>
                  <a:txBody>
                    <a:bodyPr/>
                    <a:lstStyle/>
                    <a:p>
                      <a:pPr algn="l" fontAlgn="b"/>
                      <a:r>
                        <a:rPr lang="is-IS" sz="1100" u="none" strike="noStrike">
                          <a:effectLst/>
                          <a:latin typeface="+mn-lt"/>
                        </a:rPr>
                        <a:t>2288868</a:t>
                      </a:r>
                      <a:endParaRPr lang="is-I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SN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_tradnl" sz="1100" u="none" strike="noStrike">
                          <a:effectLst/>
                          <a:latin typeface="+mn-lt"/>
                        </a:rPr>
                        <a:t>C,T</a:t>
                      </a:r>
                      <a:endParaRPr lang="es-ES_tradnl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mr-IN" sz="1100" u="none" strike="noStrike">
                          <a:effectLst/>
                          <a:latin typeface="+mn-lt"/>
                        </a:rPr>
                        <a:t>125V&gt;G, 125V&gt;D</a:t>
                      </a:r>
                      <a:endParaRPr lang="mr-IN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</a:tr>
              <a:tr h="118756">
                <a:tc>
                  <a:txBody>
                    <a:bodyPr/>
                    <a:lstStyle/>
                    <a:p>
                      <a:pPr algn="l" fontAlgn="b"/>
                      <a:r>
                        <a:rPr lang="cs-CZ" sz="1100" u="none" strike="noStrike">
                          <a:effectLst/>
                          <a:latin typeface="+mn-lt"/>
                        </a:rPr>
                        <a:t>2289103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SN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_tradnl" sz="1100" u="none" strike="noStrike">
                          <a:effectLst/>
                          <a:latin typeface="+mn-lt"/>
                        </a:rPr>
                        <a:t>C,G</a:t>
                      </a:r>
                      <a:endParaRPr lang="es-ES_tradnl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mr-IN" sz="1100" u="none" strike="noStrike">
                          <a:effectLst/>
                          <a:latin typeface="+mn-lt"/>
                        </a:rPr>
                        <a:t>47T&gt;A, 47T&gt;P</a:t>
                      </a:r>
                      <a:endParaRPr lang="mr-IN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</a:tr>
              <a:tr h="149640">
                <a:tc>
                  <a:txBody>
                    <a:bodyPr/>
                    <a:lstStyle/>
                    <a:p>
                      <a:pPr algn="l" fontAlgn="b"/>
                      <a:r>
                        <a:rPr lang="is-IS" sz="1100" u="none" strike="noStrike">
                          <a:effectLst/>
                          <a:latin typeface="+mn-lt"/>
                        </a:rPr>
                        <a:t>2289207</a:t>
                      </a:r>
                      <a:endParaRPr lang="is-I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SN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_tradnl" sz="1100" u="none" strike="noStrike">
                          <a:effectLst/>
                          <a:latin typeface="+mn-lt"/>
                        </a:rPr>
                        <a:t>C,G</a:t>
                      </a:r>
                      <a:endParaRPr lang="es-ES_tradnl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mr-IN" sz="1100" u="none" strike="noStrike">
                          <a:effectLst/>
                          <a:latin typeface="+mn-lt"/>
                        </a:rPr>
                        <a:t>12D&gt;G, 12D&gt;A</a:t>
                      </a:r>
                      <a:endParaRPr lang="mr-IN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</a:tr>
              <a:tr h="114669">
                <a:tc>
                  <a:txBody>
                    <a:bodyPr/>
                    <a:lstStyle/>
                    <a:p>
                      <a:pPr algn="l" fontAlgn="b"/>
                      <a:r>
                        <a:rPr lang="is-IS" sz="1100" u="none" strike="noStrike">
                          <a:effectLst/>
                          <a:latin typeface="+mn-lt"/>
                        </a:rPr>
                        <a:t>2747471</a:t>
                      </a:r>
                      <a:endParaRPr lang="is-I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SN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_tradnl" sz="1100" u="none" strike="noStrike">
                          <a:effectLst/>
                          <a:latin typeface="+mn-lt"/>
                        </a:rPr>
                        <a:t>C,G</a:t>
                      </a:r>
                      <a:endParaRPr lang="es-ES_tradnl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mr-IN" sz="1100" u="none" strike="noStrike">
                          <a:effectLst/>
                          <a:latin typeface="+mn-lt"/>
                        </a:rPr>
                        <a:t>43I&gt;S, 43I&gt;T</a:t>
                      </a:r>
                      <a:endParaRPr lang="mr-IN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</a:tr>
              <a:tr h="115710">
                <a:tc>
                  <a:txBody>
                    <a:bodyPr/>
                    <a:lstStyle/>
                    <a:p>
                      <a:pPr algn="l" fontAlgn="b"/>
                      <a:r>
                        <a:rPr lang="is-IS" sz="1100" u="none" strike="noStrike">
                          <a:effectLst/>
                          <a:latin typeface="+mn-lt"/>
                        </a:rPr>
                        <a:t>4247429</a:t>
                      </a:r>
                      <a:endParaRPr lang="is-I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SN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_tradnl" sz="1100" u="none" strike="noStrike">
                          <a:effectLst/>
                          <a:latin typeface="+mn-lt"/>
                        </a:rPr>
                        <a:t>C,G</a:t>
                      </a:r>
                      <a:endParaRPr lang="es-ES_tradnl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mr-IN" sz="1100" u="none" strike="noStrike">
                          <a:effectLst/>
                          <a:latin typeface="+mn-lt"/>
                        </a:rPr>
                        <a:t>306M&gt;L, 306M&gt;V</a:t>
                      </a:r>
                      <a:endParaRPr lang="mr-IN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</a:tr>
              <a:tr h="163558">
                <a:tc>
                  <a:txBody>
                    <a:bodyPr/>
                    <a:lstStyle/>
                    <a:p>
                      <a:pPr algn="l" fontAlgn="b"/>
                      <a:r>
                        <a:rPr lang="is-IS" sz="1100" u="none" strike="noStrike">
                          <a:effectLst/>
                          <a:latin typeface="+mn-lt"/>
                        </a:rPr>
                        <a:t>4247431</a:t>
                      </a:r>
                      <a:endParaRPr lang="is-I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SN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_tradnl" sz="1100" u="none" strike="noStrike">
                          <a:effectLst/>
                          <a:latin typeface="+mn-lt"/>
                        </a:rPr>
                        <a:t>C,A,T</a:t>
                      </a:r>
                      <a:endParaRPr lang="es-ES_tradnl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mr-IN" sz="1100" u="none" strike="noStrike" dirty="0" smtClean="0">
                          <a:effectLst/>
                          <a:latin typeface="+mn-lt"/>
                        </a:rPr>
                        <a:t>306M&gt;I, </a:t>
                      </a:r>
                      <a:r>
                        <a:rPr lang="mr-IN" sz="1100" u="none" strike="noStrike" dirty="0">
                          <a:effectLst/>
                          <a:latin typeface="+mn-lt"/>
                        </a:rPr>
                        <a:t>306M&gt;I, 306M&gt;I</a:t>
                      </a:r>
                      <a:endParaRPr lang="mr-IN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</a:tr>
              <a:tr h="186617">
                <a:tc>
                  <a:txBody>
                    <a:bodyPr/>
                    <a:lstStyle/>
                    <a:p>
                      <a:pPr algn="l" fontAlgn="b"/>
                      <a:r>
                        <a:rPr lang="is-IS" sz="1100" u="none" strike="noStrike">
                          <a:effectLst/>
                          <a:latin typeface="+mn-lt"/>
                        </a:rPr>
                        <a:t>4247469</a:t>
                      </a:r>
                      <a:endParaRPr lang="is-I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SN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_tradnl" sz="1100" u="none" strike="noStrike">
                          <a:effectLst/>
                          <a:latin typeface="+mn-lt"/>
                        </a:rPr>
                        <a:t>C,G</a:t>
                      </a:r>
                      <a:endParaRPr lang="es-ES_tradnl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mr-IN" sz="1100" u="none" strike="noStrike" dirty="0">
                          <a:effectLst/>
                          <a:latin typeface="+mn-lt"/>
                        </a:rPr>
                        <a:t>319Y&gt;</a:t>
                      </a:r>
                      <a:r>
                        <a:rPr lang="mr-IN" sz="1100" u="none" strike="noStrike" dirty="0" err="1">
                          <a:effectLst/>
                          <a:latin typeface="+mn-lt"/>
                        </a:rPr>
                        <a:t>S</a:t>
                      </a:r>
                      <a:r>
                        <a:rPr lang="mr-IN" sz="1100" u="none" strike="noStrike" dirty="0">
                          <a:effectLst/>
                          <a:latin typeface="+mn-lt"/>
                        </a:rPr>
                        <a:t>, 319Y&gt;C</a:t>
                      </a:r>
                      <a:endParaRPr lang="mr-IN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</a:tr>
              <a:tr h="152687">
                <a:tc>
                  <a:txBody>
                    <a:bodyPr/>
                    <a:lstStyle/>
                    <a:p>
                      <a:pPr algn="l" fontAlgn="b"/>
                      <a:r>
                        <a:rPr lang="is-IS" sz="1100" u="none" strike="noStrike" dirty="0">
                          <a:effectLst/>
                          <a:latin typeface="+mn-lt"/>
                        </a:rPr>
                        <a:t>4247574</a:t>
                      </a:r>
                      <a:endParaRPr lang="is-I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SN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C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mr-IN" sz="1100" u="none" strike="noStrike" dirty="0">
                          <a:effectLst/>
                          <a:latin typeface="+mn-lt"/>
                        </a:rPr>
                        <a:t>354D&gt;</a:t>
                      </a:r>
                      <a:r>
                        <a:rPr lang="mr-IN" sz="1100" u="none" strike="noStrike" dirty="0" err="1">
                          <a:effectLst/>
                          <a:latin typeface="+mn-lt"/>
                        </a:rPr>
                        <a:t>A</a:t>
                      </a:r>
                      <a:endParaRPr lang="mr-IN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</a:tr>
              <a:tr h="152686">
                <a:tc>
                  <a:txBody>
                    <a:bodyPr/>
                    <a:lstStyle/>
                    <a:p>
                      <a:pPr algn="l" fontAlgn="b"/>
                      <a:r>
                        <a:rPr lang="is-IS" sz="1100" u="none" strike="noStrike">
                          <a:effectLst/>
                          <a:latin typeface="+mn-lt"/>
                        </a:rPr>
                        <a:t>4247729</a:t>
                      </a:r>
                      <a:endParaRPr lang="is-I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SN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_tradnl" sz="1100" u="none" strike="noStrike">
                          <a:effectLst/>
                          <a:latin typeface="+mn-lt"/>
                        </a:rPr>
                        <a:t>A,T</a:t>
                      </a:r>
                      <a:endParaRPr lang="es-ES_tradnl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mr-IN" sz="1100" u="none" strike="noStrike" dirty="0">
                          <a:effectLst/>
                          <a:latin typeface="+mn-lt"/>
                        </a:rPr>
                        <a:t>406G&gt;</a:t>
                      </a:r>
                      <a:r>
                        <a:rPr lang="mr-IN" sz="1100" u="none" strike="noStrike" dirty="0" err="1">
                          <a:effectLst/>
                          <a:latin typeface="+mn-lt"/>
                        </a:rPr>
                        <a:t>T</a:t>
                      </a:r>
                      <a:r>
                        <a:rPr lang="mr-IN" sz="1100" u="none" strike="noStrike" dirty="0">
                          <a:effectLst/>
                          <a:latin typeface="+mn-lt"/>
                        </a:rPr>
                        <a:t>, 406G&gt;</a:t>
                      </a:r>
                      <a:r>
                        <a:rPr lang="mr-IN" sz="1100" u="none" strike="noStrike" dirty="0" err="1">
                          <a:effectLst/>
                          <a:latin typeface="+mn-lt"/>
                        </a:rPr>
                        <a:t>Y</a:t>
                      </a:r>
                      <a:endParaRPr lang="mr-IN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</a:tr>
              <a:tr h="135722">
                <a:tc>
                  <a:txBody>
                    <a:bodyPr/>
                    <a:lstStyle/>
                    <a:p>
                      <a:pPr algn="l" fontAlgn="b"/>
                      <a:r>
                        <a:rPr lang="is-IS" sz="1100" u="none" strike="noStrike">
                          <a:effectLst/>
                          <a:latin typeface="+mn-lt"/>
                        </a:rPr>
                        <a:t>4247730</a:t>
                      </a:r>
                      <a:endParaRPr lang="is-I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SN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_tradnl" sz="1100" u="none" strike="noStrike">
                          <a:effectLst/>
                          <a:latin typeface="+mn-lt"/>
                        </a:rPr>
                        <a:t>C,A</a:t>
                      </a:r>
                      <a:endParaRPr lang="es-ES_tradnl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mr-IN" sz="1100" u="none" strike="noStrike">
                          <a:effectLst/>
                          <a:latin typeface="+mn-lt"/>
                        </a:rPr>
                        <a:t>406G&gt;A, 406G&gt;D</a:t>
                      </a:r>
                      <a:endParaRPr lang="mr-IN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</a:tr>
              <a:tr h="135721">
                <a:tc>
                  <a:txBody>
                    <a:bodyPr/>
                    <a:lstStyle/>
                    <a:p>
                      <a:pPr algn="l" fontAlgn="b"/>
                      <a:r>
                        <a:rPr lang="is-IS" sz="1100" u="none" strike="noStrike">
                          <a:effectLst/>
                          <a:latin typeface="+mn-lt"/>
                        </a:rPr>
                        <a:t>4248003</a:t>
                      </a:r>
                      <a:endParaRPr lang="is-I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SN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_tradnl" sz="1100" u="none" strike="noStrike">
                          <a:effectLst/>
                          <a:latin typeface="+mn-lt"/>
                        </a:rPr>
                        <a:t>C,G</a:t>
                      </a:r>
                      <a:endParaRPr lang="es-ES_tradnl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mr-IN" sz="1100" u="none" strike="noStrike" dirty="0">
                          <a:effectLst/>
                          <a:latin typeface="+mn-lt"/>
                        </a:rPr>
                        <a:t>497Q&gt;</a:t>
                      </a:r>
                      <a:r>
                        <a:rPr lang="mr-IN" sz="1100" u="none" strike="noStrike" dirty="0" err="1">
                          <a:effectLst/>
                          <a:latin typeface="+mn-lt"/>
                        </a:rPr>
                        <a:t>P</a:t>
                      </a:r>
                      <a:r>
                        <a:rPr lang="mr-IN" sz="1100" u="none" strike="noStrike" dirty="0">
                          <a:effectLst/>
                          <a:latin typeface="+mn-lt"/>
                        </a:rPr>
                        <a:t>, 497Q&gt;</a:t>
                      </a:r>
                      <a:r>
                        <a:rPr lang="mr-IN" sz="1100" u="none" strike="noStrike" dirty="0" err="1">
                          <a:effectLst/>
                          <a:latin typeface="+mn-lt"/>
                        </a:rPr>
                        <a:t>R</a:t>
                      </a:r>
                      <a:endParaRPr lang="mr-IN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</a:tr>
              <a:tr h="114669">
                <a:tc>
                  <a:txBody>
                    <a:bodyPr/>
                    <a:lstStyle/>
                    <a:p>
                      <a:pPr algn="l" fontAlgn="b"/>
                      <a:r>
                        <a:rPr lang="cs-CZ" sz="1100" u="none" strike="noStrike">
                          <a:effectLst/>
                          <a:latin typeface="+mn-lt"/>
                        </a:rPr>
                        <a:t>4249518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SN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mr-IN" sz="1100" u="none" strike="noStrike">
                          <a:effectLst/>
                          <a:latin typeface="+mn-lt"/>
                        </a:rPr>
                        <a:t>1002H&gt;R</a:t>
                      </a:r>
                      <a:endParaRPr lang="mr-IN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</a:tr>
              <a:tr h="121693">
                <a:tc>
                  <a:txBody>
                    <a:bodyPr/>
                    <a:lstStyle/>
                    <a:p>
                      <a:pPr algn="l" fontAlgn="b"/>
                      <a:r>
                        <a:rPr lang="is-IS" sz="1100" u="none" strike="noStrike">
                          <a:effectLst/>
                          <a:latin typeface="+mn-lt"/>
                        </a:rPr>
                        <a:t>761139</a:t>
                      </a:r>
                      <a:endParaRPr lang="is-I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Inde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CAC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mr-IN" sz="1100" u="none" strike="noStrike">
                          <a:effectLst/>
                          <a:latin typeface="+mn-lt"/>
                        </a:rPr>
                        <a:t>445HK&gt;Q</a:t>
                      </a:r>
                      <a:endParaRPr lang="mr-IN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</a:tr>
              <a:tr h="224020">
                <a:tc>
                  <a:txBody>
                    <a:bodyPr/>
                    <a:lstStyle/>
                    <a:p>
                      <a:pPr algn="l" fontAlgn="b"/>
                      <a:r>
                        <a:rPr lang="is-IS" sz="1100" u="none" strike="noStrike">
                          <a:effectLst/>
                          <a:latin typeface="+mn-lt"/>
                        </a:rPr>
                        <a:t>2288778</a:t>
                      </a:r>
                      <a:endParaRPr lang="is-I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Inde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AC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155VLVDLTAGVSADTTVAALEEMRTASVELVCSS*&gt;155GAGGPDSGCVGRYHRRRAGGDAHRQRRVGLQLL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</a:tr>
              <a:tr h="442723">
                <a:tc>
                  <a:txBody>
                    <a:bodyPr/>
                    <a:lstStyle/>
                    <a:p>
                      <a:pPr algn="l" fontAlgn="b"/>
                      <a:r>
                        <a:rPr lang="is-IS" sz="1100" u="none" strike="noStrike">
                          <a:effectLst/>
                          <a:latin typeface="+mn-lt"/>
                        </a:rPr>
                        <a:t>2289207</a:t>
                      </a:r>
                      <a:endParaRPr lang="is-I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Inde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  <a:latin typeface="+mn-lt"/>
                        </a:rPr>
                        <a:t>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T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+mn-lt"/>
                        </a:rPr>
                        <a:t>12DFCEGGSLAVTGGAALARAISDYLAEAADYHHVVATKDFHIDPGDHFSGTPDYSSSWPPHCVSGTPGADFHPSLDTSAIEAVFYKGAYTGAYSGFEGVDENGTPLLNWLRQRGVDEVDVVGIATDHCVRQTAEDAVRNGLATRVLVDLTAGVSADTTVAALEEMRTASVELVCSS*&gt;12GLLRGWLAGGNRWRRAGPRHQRLPGRSGGLPSRRGNQGLPHRPG*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7411" marR="7411" marT="7411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5122796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610</TotalTime>
  <Words>331</Words>
  <Application>Microsoft Macintosh PowerPoint</Application>
  <PresentationFormat>A4 Paper (210x297 mm)</PresentationFormat>
  <Paragraphs>22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Calibri</vt:lpstr>
      <vt:lpstr>Calibri Light</vt:lpstr>
      <vt:lpstr>Mangal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28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ppong, Yaa</dc:creator>
  <cp:lastModifiedBy>Oppong, Yaa</cp:lastModifiedBy>
  <cp:revision>9</cp:revision>
  <cp:lastPrinted>2019-01-15T15:40:31Z</cp:lastPrinted>
  <dcterms:created xsi:type="dcterms:W3CDTF">2018-02-01T17:47:13Z</dcterms:created>
  <dcterms:modified xsi:type="dcterms:W3CDTF">2019-01-16T15:05:37Z</dcterms:modified>
</cp:coreProperties>
</file>